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0" autoAdjust="0"/>
    <p:restoredTop sz="94660"/>
  </p:normalViewPr>
  <p:slideViewPr>
    <p:cSldViewPr snapToGrid="0">
      <p:cViewPr varScale="1">
        <p:scale>
          <a:sx n="71" d="100"/>
          <a:sy n="71" d="100"/>
        </p:scale>
        <p:origin x="40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1025%20wm4%20PEV%20cross%20for%20reviewer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2DC-4E70-BBFA-134954591DE2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2DC-4E70-BBFA-134954591DE2}"/>
              </c:ext>
            </c:extLst>
          </c:dPt>
          <c:dPt>
            <c:idx val="2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2DC-4E70-BBFA-134954591DE2}"/>
              </c:ext>
            </c:extLst>
          </c:dPt>
          <c:val>
            <c:numRef>
              <c:f>'Oct wm4 crosses (3 class'!$C$15:$E$15</c:f>
              <c:numCache>
                <c:formatCode>General</c:formatCode>
                <c:ptCount val="3"/>
                <c:pt idx="0">
                  <c:v>0</c:v>
                </c:pt>
                <c:pt idx="1">
                  <c:v>59.349593495934961</c:v>
                </c:pt>
                <c:pt idx="2">
                  <c:v>40.6504065040650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2DC-4E70-BBFA-134954591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>
                  <a:alpha val="76000"/>
                </a:schemeClr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tx1">
                    <a:alpha val="76000"/>
                  </a:scheme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8FA-46D5-B9A8-72F960C1FD1F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>
                    <a:alpha val="76000"/>
                  </a:scheme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8FA-46D5-B9A8-72F960C1FD1F}"/>
              </c:ext>
            </c:extLst>
          </c:dPt>
          <c:dPt>
            <c:idx val="2"/>
            <c:bubble3D val="0"/>
            <c:spPr>
              <a:solidFill>
                <a:schemeClr val="bg1"/>
              </a:solidFill>
              <a:ln w="19050">
                <a:solidFill>
                  <a:schemeClr val="tx1">
                    <a:alpha val="76000"/>
                  </a:scheme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8FA-46D5-B9A8-72F960C1FD1F}"/>
              </c:ext>
            </c:extLst>
          </c:dPt>
          <c:val>
            <c:numRef>
              <c:f>'Oct wm4 crosses (3 class'!$F$15:$H$15</c:f>
              <c:numCache>
                <c:formatCode>General</c:formatCode>
                <c:ptCount val="3"/>
                <c:pt idx="0">
                  <c:v>55.614973262032088</c:v>
                </c:pt>
                <c:pt idx="1">
                  <c:v>42.780748663101605</c:v>
                </c:pt>
                <c:pt idx="2">
                  <c:v>1.60427807486631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8FA-46D5-B9A8-72F960C1FD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B31-43FB-BE2D-C1D19E32B4C6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B31-43FB-BE2D-C1D19E32B4C6}"/>
              </c:ext>
            </c:extLst>
          </c:dPt>
          <c:dPt>
            <c:idx val="2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B31-43FB-BE2D-C1D19E32B4C6}"/>
              </c:ext>
            </c:extLst>
          </c:dPt>
          <c:val>
            <c:numRef>
              <c:f>'Oct wm4 crosses (3 class'!$O$15:$Q$15</c:f>
              <c:numCache>
                <c:formatCode>General</c:formatCode>
                <c:ptCount val="3"/>
                <c:pt idx="0">
                  <c:v>10.666666666666666</c:v>
                </c:pt>
                <c:pt idx="1">
                  <c:v>85.333333333333329</c:v>
                </c:pt>
                <c:pt idx="2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B31-43FB-BE2D-C1D19E32B4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771-4466-B750-89C609342D51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771-4466-B750-89C609342D51}"/>
              </c:ext>
            </c:extLst>
          </c:dPt>
          <c:dPt>
            <c:idx val="2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771-4466-B750-89C609342D51}"/>
              </c:ext>
            </c:extLst>
          </c:dPt>
          <c:val>
            <c:numRef>
              <c:f>'Oct wm4 crosses (3 class'!$L$15:$N$15</c:f>
              <c:numCache>
                <c:formatCode>General</c:formatCode>
                <c:ptCount val="3"/>
                <c:pt idx="0">
                  <c:v>0</c:v>
                </c:pt>
                <c:pt idx="1">
                  <c:v>46.774193548387096</c:v>
                </c:pt>
                <c:pt idx="2">
                  <c:v>53.2258064516129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2771-4466-B750-89C609342D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02A-46C5-B685-9670D9B61CB6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02A-46C5-B685-9670D9B61CB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02A-46C5-B685-9670D9B61CB6}"/>
              </c:ext>
            </c:extLst>
          </c:dPt>
          <c:val>
            <c:numRef>
              <c:f>'Oct wm4 crosses (3 class'!$R$15:$T$15</c:f>
              <c:numCache>
                <c:formatCode>General</c:formatCode>
                <c:ptCount val="3"/>
                <c:pt idx="0">
                  <c:v>71.71052631578948</c:v>
                </c:pt>
                <c:pt idx="1">
                  <c:v>28.289473684210527</c:v>
                </c:pt>
                <c:pt idx="2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02A-46C5-B685-9670D9B61C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FF4-4433-A069-3FC3EB484486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FF4-4433-A069-3FC3EB48448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FF4-4433-A069-3FC3EB484486}"/>
              </c:ext>
            </c:extLst>
          </c:dPt>
          <c:val>
            <c:numRef>
              <c:f>'Oct wm4 crosses (3 class'!$X$15:$Z$15</c:f>
              <c:numCache>
                <c:formatCode>General</c:formatCode>
                <c:ptCount val="3"/>
                <c:pt idx="0">
                  <c:v>15.217391304347826</c:v>
                </c:pt>
                <c:pt idx="1">
                  <c:v>84.782608695652172</c:v>
                </c:pt>
                <c:pt idx="2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DFF4-4433-A069-3FC3EB4844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A3CE-4578-8293-4462681F444C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A3CE-4578-8293-4462681F444C}"/>
              </c:ext>
            </c:extLst>
          </c:dPt>
          <c:dPt>
            <c:idx val="2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A3CE-4578-8293-4462681F444C}"/>
              </c:ext>
            </c:extLst>
          </c:dPt>
          <c:val>
            <c:numRef>
              <c:f>'Oct wm4 crosses (3 class'!$I$15:$K$15</c:f>
              <c:numCache>
                <c:formatCode>General</c:formatCode>
                <c:ptCount val="3"/>
                <c:pt idx="0">
                  <c:v>0.84745762711864403</c:v>
                </c:pt>
                <c:pt idx="1">
                  <c:v>77.118644067796609</c:v>
                </c:pt>
                <c:pt idx="2">
                  <c:v>22.0338983050847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A3CE-4578-8293-4462681F44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bubble3D val="0"/>
            <c:spPr>
              <a:solidFill>
                <a:srgbClr val="C00000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5CE-4C54-B02D-6C163117423A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5CE-4C54-B02D-6C163117423A}"/>
              </c:ext>
            </c:extLst>
          </c:dPt>
          <c:dPt>
            <c:idx val="2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5CE-4C54-B02D-6C163117423A}"/>
              </c:ext>
            </c:extLst>
          </c:dPt>
          <c:val>
            <c:numRef>
              <c:f>'Oct wm4 crosses (3 class'!$U$15:$W$15</c:f>
              <c:numCache>
                <c:formatCode>General</c:formatCode>
                <c:ptCount val="3"/>
                <c:pt idx="0">
                  <c:v>10.679611650485437</c:v>
                </c:pt>
                <c:pt idx="1">
                  <c:v>85.4368932038835</c:v>
                </c:pt>
                <c:pt idx="2">
                  <c:v>3.8834951456310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95CE-4C54-B02D-6C16311742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6A621C-225D-4D54-A204-17169D8365AC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386A3C-1EC4-418B-AAC1-701C24D27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277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362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701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2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41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80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568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2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1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569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161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84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24000" y="6488668"/>
            <a:ext cx="47626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Figure S6: PEV of w</a:t>
            </a:r>
            <a:r>
              <a:rPr lang="en-US" baseline="30000" dirty="0">
                <a:solidFill>
                  <a:prstClr val="black"/>
                </a:solidFill>
              </a:rPr>
              <a:t>m4</a:t>
            </a:r>
            <a:r>
              <a:rPr lang="en-US" dirty="0">
                <a:solidFill>
                  <a:prstClr val="black"/>
                </a:solidFill>
              </a:rPr>
              <a:t> across all genotypes tested</a:t>
            </a:r>
            <a:endParaRPr lang="en-US" baseline="30000" dirty="0">
              <a:solidFill>
                <a:prstClr val="black"/>
              </a:solidFill>
            </a:endParaRPr>
          </a:p>
        </p:txBody>
      </p:sp>
      <p:sp>
        <p:nvSpPr>
          <p:cNvPr id="12" name="Oval 11"/>
          <p:cNvSpPr/>
          <p:nvPr/>
        </p:nvSpPr>
        <p:spPr>
          <a:xfrm>
            <a:off x="1523602" y="3163519"/>
            <a:ext cx="213756" cy="213756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x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846623" y="2995029"/>
            <a:ext cx="3441818" cy="646331"/>
            <a:chOff x="446573" y="2807490"/>
            <a:chExt cx="3441818" cy="646331"/>
          </a:xfrm>
        </p:grpSpPr>
        <p:sp>
          <p:nvSpPr>
            <p:cNvPr id="11" name="TextBox 10"/>
            <p:cNvSpPr txBox="1"/>
            <p:nvPr/>
          </p:nvSpPr>
          <p:spPr>
            <a:xfrm>
              <a:off x="446573" y="2807490"/>
              <a:ext cx="55175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u="sng" dirty="0"/>
                <a:t>w</a:t>
              </a:r>
              <a:r>
                <a:rPr lang="en-US" i="1" u="sng" baseline="30000" dirty="0"/>
                <a:t>m4</a:t>
              </a:r>
            </a:p>
            <a:p>
              <a:r>
                <a:rPr lang="en-US" i="1" dirty="0"/>
                <a:t>w</a:t>
              </a:r>
              <a:r>
                <a:rPr lang="en-US" i="1" baseline="30000" dirty="0"/>
                <a:t>m4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1722923" y="2807490"/>
              <a:ext cx="2165468" cy="646331"/>
              <a:chOff x="1571562" y="2568015"/>
              <a:chExt cx="2165468" cy="646331"/>
            </a:xfrm>
          </p:grpSpPr>
          <p:grpSp>
            <p:nvGrpSpPr>
              <p:cNvPr id="14" name="Group 15"/>
              <p:cNvGrpSpPr/>
              <p:nvPr/>
            </p:nvGrpSpPr>
            <p:grpSpPr>
              <a:xfrm>
                <a:off x="1571562" y="2568015"/>
                <a:ext cx="454868" cy="646331"/>
                <a:chOff x="2635178" y="3810000"/>
                <a:chExt cx="454868" cy="646331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>
                  <a:off x="2635178" y="3810000"/>
                  <a:ext cx="454868" cy="6463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i="1" u="sng" dirty="0" err="1"/>
                    <a:t>yw</a:t>
                  </a:r>
                  <a:endParaRPr lang="en-US" i="1" u="sng" dirty="0"/>
                </a:p>
                <a:p>
                  <a:endParaRPr lang="en-US" i="1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4757325">
                  <a:off x="2720283" y="4029947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7</a:t>
                  </a:r>
                </a:p>
              </p:txBody>
            </p:sp>
          </p:grpSp>
          <p:sp>
            <p:nvSpPr>
              <p:cNvPr id="15" name="TextBox 14"/>
              <p:cNvSpPr txBox="1"/>
              <p:nvPr/>
            </p:nvSpPr>
            <p:spPr>
              <a:xfrm>
                <a:off x="1983857" y="2568015"/>
                <a:ext cx="175317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l-GR" i="1" u="sng" dirty="0"/>
                  <a:t>Δ</a:t>
                </a:r>
                <a:r>
                  <a:rPr lang="en-US" i="1" u="sng" dirty="0" err="1"/>
                  <a:t>DsRed</a:t>
                </a:r>
                <a:r>
                  <a:rPr lang="el-GR" i="1" u="sng" dirty="0"/>
                  <a:t>Δ</a:t>
                </a:r>
                <a:r>
                  <a:rPr lang="en-US" i="1" u="sng" dirty="0"/>
                  <a:t>{</a:t>
                </a:r>
                <a:r>
                  <a:rPr lang="en-US" i="1" u="sng" dirty="0" err="1"/>
                  <a:t>upSET</a:t>
                </a:r>
                <a:r>
                  <a:rPr lang="en-US" i="1" u="sng" dirty="0"/>
                  <a:t>}</a:t>
                </a:r>
              </a:p>
              <a:p>
                <a:pPr algn="ctr"/>
                <a:r>
                  <a:rPr lang="en-US" dirty="0"/>
                  <a:t>TM3 </a:t>
                </a:r>
                <a:r>
                  <a:rPr lang="en-US" i="1" dirty="0"/>
                  <a:t>Sb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882200" y="2694639"/>
                <a:ext cx="24718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;</a:t>
                </a:r>
              </a:p>
            </p:txBody>
          </p:sp>
        </p:grpSp>
      </p:grpSp>
      <p:grpSp>
        <p:nvGrpSpPr>
          <p:cNvPr id="31" name="Group 30"/>
          <p:cNvGrpSpPr/>
          <p:nvPr/>
        </p:nvGrpSpPr>
        <p:grpSpPr>
          <a:xfrm>
            <a:off x="2122973" y="867993"/>
            <a:ext cx="1703415" cy="646331"/>
            <a:chOff x="1571562" y="2568015"/>
            <a:chExt cx="1703415" cy="646331"/>
          </a:xfrm>
        </p:grpSpPr>
        <p:grpSp>
          <p:nvGrpSpPr>
            <p:cNvPr id="32" name="Group 15"/>
            <p:cNvGrpSpPr/>
            <p:nvPr/>
          </p:nvGrpSpPr>
          <p:grpSpPr>
            <a:xfrm>
              <a:off x="1571562" y="2568015"/>
              <a:ext cx="454868" cy="646331"/>
              <a:chOff x="2635178" y="3810000"/>
              <a:chExt cx="454868" cy="646331"/>
            </a:xfrm>
          </p:grpSpPr>
          <p:sp>
            <p:nvSpPr>
              <p:cNvPr id="35" name="TextBox 34"/>
              <p:cNvSpPr txBox="1"/>
              <p:nvPr/>
            </p:nvSpPr>
            <p:spPr>
              <a:xfrm>
                <a:off x="2635178" y="3810000"/>
                <a:ext cx="45486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u="sng" dirty="0" err="1"/>
                  <a:t>yw</a:t>
                </a:r>
                <a:endParaRPr lang="en-US" i="1" u="sng" dirty="0"/>
              </a:p>
              <a:p>
                <a:endParaRPr lang="en-US" i="1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4757325">
                <a:off x="2720283" y="402994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2445904" y="2568015"/>
              <a:ext cx="82907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u="sng" dirty="0"/>
                <a:t>     +     </a:t>
              </a:r>
            </a:p>
            <a:p>
              <a:pPr algn="ctr"/>
              <a:r>
                <a:rPr lang="en-US" dirty="0"/>
                <a:t>+</a:t>
              </a:r>
              <a:endParaRPr lang="en-US" i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882200" y="2694639"/>
              <a:ext cx="247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;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122973" y="5122066"/>
            <a:ext cx="1743263" cy="646331"/>
            <a:chOff x="3494573" y="2074066"/>
            <a:chExt cx="1743263" cy="646331"/>
          </a:xfrm>
        </p:grpSpPr>
        <p:grpSp>
          <p:nvGrpSpPr>
            <p:cNvPr id="39" name="Group 38"/>
            <p:cNvGrpSpPr/>
            <p:nvPr/>
          </p:nvGrpSpPr>
          <p:grpSpPr>
            <a:xfrm>
              <a:off x="3494573" y="2076305"/>
              <a:ext cx="550151" cy="553998"/>
              <a:chOff x="3646973" y="2019155"/>
              <a:chExt cx="550151" cy="553998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3646973" y="2019155"/>
                <a:ext cx="550151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u="sng" dirty="0"/>
                  <a:t>w</a:t>
                </a:r>
                <a:r>
                  <a:rPr lang="en-US" i="1" u="sng" baseline="30000" dirty="0"/>
                  <a:t>m4</a:t>
                </a:r>
              </a:p>
              <a:p>
                <a:endParaRPr lang="en-US" i="1" baseline="300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4757325">
                <a:off x="3771205" y="223686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3883159" y="2181640"/>
              <a:ext cx="247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;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408763" y="2074066"/>
              <a:ext cx="82907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u="sng" dirty="0"/>
                <a:t>     +     </a:t>
              </a:r>
            </a:p>
            <a:p>
              <a:pPr algn="ctr"/>
              <a:r>
                <a:rPr lang="en-US" dirty="0"/>
                <a:t>+</a:t>
              </a:r>
              <a:endParaRPr lang="en-US" i="1" dirty="0"/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4958362" y="863617"/>
            <a:ext cx="2049949" cy="923330"/>
            <a:chOff x="4558312" y="654067"/>
            <a:chExt cx="2049949" cy="923330"/>
          </a:xfrm>
        </p:grpSpPr>
        <p:sp>
          <p:nvSpPr>
            <p:cNvPr id="27" name="TextBox 26"/>
            <p:cNvSpPr txBox="1"/>
            <p:nvPr/>
          </p:nvSpPr>
          <p:spPr>
            <a:xfrm>
              <a:off x="5779188" y="658443"/>
              <a:ext cx="82907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u="sng" dirty="0"/>
                <a:t>     +     </a:t>
              </a:r>
              <a:endParaRPr lang="en-US" i="1" u="sng" dirty="0"/>
            </a:p>
            <a:p>
              <a:pPr algn="ctr"/>
              <a:r>
                <a:rPr lang="en-US" dirty="0"/>
                <a:t>+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167757" y="785067"/>
              <a:ext cx="247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;</a:t>
              </a:r>
            </a:p>
          </p:txBody>
        </p:sp>
        <p:grpSp>
          <p:nvGrpSpPr>
            <p:cNvPr id="60" name="Group 15"/>
            <p:cNvGrpSpPr/>
            <p:nvPr/>
          </p:nvGrpSpPr>
          <p:grpSpPr>
            <a:xfrm>
              <a:off x="4558312" y="654067"/>
              <a:ext cx="794189" cy="923330"/>
              <a:chOff x="2542972" y="3810000"/>
              <a:chExt cx="794189" cy="923330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2542972" y="3810000"/>
                <a:ext cx="761747" cy="923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u="sng" dirty="0"/>
                  <a:t>  w</a:t>
                </a:r>
                <a:r>
                  <a:rPr lang="en-US" i="1" u="sng" baseline="30000" dirty="0"/>
                  <a:t>m4   </a:t>
                </a:r>
              </a:p>
              <a:p>
                <a:r>
                  <a:rPr lang="en-US" i="1" dirty="0" err="1"/>
                  <a:t>yw</a:t>
                </a:r>
                <a:r>
                  <a:rPr lang="en-US" i="1" dirty="0"/>
                  <a:t> /</a:t>
                </a:r>
              </a:p>
              <a:p>
                <a:endParaRPr lang="en-US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rot="14757325">
                <a:off x="3001652" y="409979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</p:grpSp>
      </p:grpSp>
      <p:grpSp>
        <p:nvGrpSpPr>
          <p:cNvPr id="70" name="Group 69"/>
          <p:cNvGrpSpPr/>
          <p:nvPr/>
        </p:nvGrpSpPr>
        <p:grpSpPr>
          <a:xfrm>
            <a:off x="4958362" y="2286017"/>
            <a:ext cx="2534369" cy="2345730"/>
            <a:chOff x="4558312" y="2076467"/>
            <a:chExt cx="2534369" cy="2345730"/>
          </a:xfrm>
        </p:grpSpPr>
        <p:grpSp>
          <p:nvGrpSpPr>
            <p:cNvPr id="20" name="Group 15"/>
            <p:cNvGrpSpPr/>
            <p:nvPr/>
          </p:nvGrpSpPr>
          <p:grpSpPr>
            <a:xfrm>
              <a:off x="4558312" y="2076467"/>
              <a:ext cx="794189" cy="923330"/>
              <a:chOff x="2542972" y="3810000"/>
              <a:chExt cx="794189" cy="923330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2542972" y="3810000"/>
                <a:ext cx="761747" cy="923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u="sng" dirty="0"/>
                  <a:t>  w</a:t>
                </a:r>
                <a:r>
                  <a:rPr lang="en-US" i="1" u="sng" baseline="30000" dirty="0"/>
                  <a:t>m4   </a:t>
                </a:r>
              </a:p>
              <a:p>
                <a:r>
                  <a:rPr lang="en-US" i="1" dirty="0" err="1"/>
                  <a:t>yw</a:t>
                </a:r>
                <a:r>
                  <a:rPr lang="en-US" i="1" dirty="0"/>
                  <a:t> /</a:t>
                </a:r>
              </a:p>
              <a:p>
                <a:endParaRPr lang="en-US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4757325">
                <a:off x="3001652" y="409979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5286609" y="2076467"/>
              <a:ext cx="180607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i="1" u="sng" dirty="0"/>
                <a:t>Δ</a:t>
              </a:r>
              <a:r>
                <a:rPr lang="en-US" i="1" u="sng" dirty="0" err="1"/>
                <a:t>DsRed</a:t>
              </a:r>
              <a:r>
                <a:rPr lang="el-GR" i="1" u="sng" dirty="0"/>
                <a:t>Δ</a:t>
              </a:r>
              <a:r>
                <a:rPr lang="en-US" i="1" u="sng" dirty="0"/>
                <a:t>{</a:t>
              </a:r>
              <a:r>
                <a:rPr lang="en-US" i="1" u="sng" dirty="0" err="1"/>
                <a:t>upSET</a:t>
              </a:r>
              <a:r>
                <a:rPr lang="en-US" i="1" u="sng" dirty="0"/>
                <a:t>}</a:t>
              </a:r>
              <a:r>
                <a:rPr lang="en-US" u="sng" dirty="0"/>
                <a:t> </a:t>
              </a:r>
            </a:p>
            <a:p>
              <a:pPr algn="ctr"/>
              <a:r>
                <a:rPr lang="en-US" dirty="0"/>
                <a:t>+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167757" y="2203091"/>
              <a:ext cx="247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;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717401" y="3494491"/>
              <a:ext cx="94448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u="sng" dirty="0"/>
                <a:t>TM3,</a:t>
              </a:r>
              <a:r>
                <a:rPr lang="en-US" i="1" u="sng" dirty="0"/>
                <a:t>Sb</a:t>
              </a:r>
              <a:r>
                <a:rPr lang="en-US" u="sng" dirty="0"/>
                <a:t> </a:t>
              </a:r>
            </a:p>
            <a:p>
              <a:pPr algn="ctr"/>
              <a:r>
                <a:rPr lang="en-US" dirty="0"/>
                <a:t>+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167757" y="3621115"/>
              <a:ext cx="247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;</a:t>
              </a:r>
            </a:p>
          </p:txBody>
        </p:sp>
        <p:grpSp>
          <p:nvGrpSpPr>
            <p:cNvPr id="63" name="Group 15"/>
            <p:cNvGrpSpPr/>
            <p:nvPr/>
          </p:nvGrpSpPr>
          <p:grpSpPr>
            <a:xfrm>
              <a:off x="4558312" y="3498867"/>
              <a:ext cx="794189" cy="923330"/>
              <a:chOff x="2542972" y="3810000"/>
              <a:chExt cx="794189" cy="923330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2542972" y="3810000"/>
                <a:ext cx="761747" cy="923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u="sng" dirty="0"/>
                  <a:t>  w</a:t>
                </a:r>
                <a:r>
                  <a:rPr lang="en-US" i="1" u="sng" baseline="30000" dirty="0"/>
                  <a:t>m4   </a:t>
                </a:r>
              </a:p>
              <a:p>
                <a:r>
                  <a:rPr lang="en-US" i="1" dirty="0" err="1"/>
                  <a:t>yw</a:t>
                </a:r>
                <a:r>
                  <a:rPr lang="en-US" i="1" dirty="0"/>
                  <a:t> /</a:t>
                </a:r>
              </a:p>
              <a:p>
                <a:endParaRPr lang="en-US" dirty="0"/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 rot="14757325">
                <a:off x="3001652" y="409979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</p:grpSp>
      </p:grpSp>
      <p:grpSp>
        <p:nvGrpSpPr>
          <p:cNvPr id="69" name="Group 68"/>
          <p:cNvGrpSpPr/>
          <p:nvPr/>
        </p:nvGrpSpPr>
        <p:grpSpPr>
          <a:xfrm>
            <a:off x="4983762" y="5122066"/>
            <a:ext cx="1806763" cy="957481"/>
            <a:chOff x="4583712" y="4912516"/>
            <a:chExt cx="1806763" cy="957481"/>
          </a:xfrm>
        </p:grpSpPr>
        <p:sp>
          <p:nvSpPr>
            <p:cNvPr id="53" name="TextBox 52"/>
            <p:cNvSpPr txBox="1"/>
            <p:nvPr/>
          </p:nvSpPr>
          <p:spPr>
            <a:xfrm>
              <a:off x="5162798" y="5020090"/>
              <a:ext cx="247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;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561402" y="4912516"/>
              <a:ext cx="82907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u="sng" dirty="0"/>
                <a:t>     +     </a:t>
              </a:r>
            </a:p>
            <a:p>
              <a:pPr algn="ctr"/>
              <a:r>
                <a:rPr lang="en-US" dirty="0"/>
                <a:t>+</a:t>
              </a:r>
              <a:endParaRPr lang="en-US" i="1" dirty="0"/>
            </a:p>
          </p:txBody>
        </p:sp>
        <p:grpSp>
          <p:nvGrpSpPr>
            <p:cNvPr id="66" name="Group 15"/>
            <p:cNvGrpSpPr/>
            <p:nvPr/>
          </p:nvGrpSpPr>
          <p:grpSpPr>
            <a:xfrm>
              <a:off x="4583712" y="4946667"/>
              <a:ext cx="794189" cy="923330"/>
              <a:chOff x="2542972" y="3810000"/>
              <a:chExt cx="794189" cy="923330"/>
            </a:xfrm>
          </p:grpSpPr>
          <p:sp>
            <p:nvSpPr>
              <p:cNvPr id="67" name="TextBox 66"/>
              <p:cNvSpPr txBox="1"/>
              <p:nvPr/>
            </p:nvSpPr>
            <p:spPr>
              <a:xfrm>
                <a:off x="2542972" y="3810000"/>
                <a:ext cx="761747" cy="9233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u="sng" dirty="0"/>
                  <a:t>  w</a:t>
                </a:r>
                <a:r>
                  <a:rPr lang="en-US" i="1" u="sng" baseline="30000" dirty="0"/>
                  <a:t>m4   </a:t>
                </a:r>
              </a:p>
              <a:p>
                <a:r>
                  <a:rPr lang="en-US" i="1" dirty="0"/>
                  <a:t>w</a:t>
                </a:r>
                <a:r>
                  <a:rPr lang="en-US" i="1" baseline="30000" dirty="0"/>
                  <a:t>m4</a:t>
                </a:r>
                <a:r>
                  <a:rPr lang="en-US" i="1" dirty="0"/>
                  <a:t>/</a:t>
                </a:r>
              </a:p>
              <a:p>
                <a:endParaRPr lang="en-US" dirty="0"/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 rot="14757325">
                <a:off x="3001652" y="409979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</p:grpSp>
      </p:grpSp>
      <p:sp>
        <p:nvSpPr>
          <p:cNvPr id="72" name="Rectangle 71"/>
          <p:cNvSpPr/>
          <p:nvPr/>
        </p:nvSpPr>
        <p:spPr>
          <a:xfrm>
            <a:off x="615950" y="387350"/>
            <a:ext cx="3733800" cy="26517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P0 </a:t>
            </a:r>
          </a:p>
        </p:txBody>
      </p:sp>
      <p:sp>
        <p:nvSpPr>
          <p:cNvPr id="73" name="Rectangle 72"/>
          <p:cNvSpPr/>
          <p:nvPr/>
        </p:nvSpPr>
        <p:spPr>
          <a:xfrm>
            <a:off x="4883150" y="387350"/>
            <a:ext cx="2651760" cy="26035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F1 </a:t>
            </a:r>
          </a:p>
        </p:txBody>
      </p:sp>
      <p:sp>
        <p:nvSpPr>
          <p:cNvPr id="78" name="Left Brace 77"/>
          <p:cNvSpPr/>
          <p:nvPr/>
        </p:nvSpPr>
        <p:spPr>
          <a:xfrm>
            <a:off x="4381500" y="2152650"/>
            <a:ext cx="742950" cy="2495550"/>
          </a:xfrm>
          <a:prstGeom prst="lef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Left Brace 78"/>
          <p:cNvSpPr/>
          <p:nvPr/>
        </p:nvSpPr>
        <p:spPr>
          <a:xfrm>
            <a:off x="1866900" y="933450"/>
            <a:ext cx="266700" cy="4762500"/>
          </a:xfrm>
          <a:prstGeom prst="lef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3" name="Group 82"/>
          <p:cNvGrpSpPr/>
          <p:nvPr/>
        </p:nvGrpSpPr>
        <p:grpSpPr>
          <a:xfrm>
            <a:off x="8562702" y="6219825"/>
            <a:ext cx="1527810" cy="365760"/>
            <a:chOff x="8477250" y="6181725"/>
            <a:chExt cx="1527810" cy="365760"/>
          </a:xfrm>
        </p:grpSpPr>
        <p:sp>
          <p:nvSpPr>
            <p:cNvPr id="80" name="Rectangle 79"/>
            <p:cNvSpPr/>
            <p:nvPr/>
          </p:nvSpPr>
          <p:spPr>
            <a:xfrm>
              <a:off x="8477250" y="6181725"/>
              <a:ext cx="365760" cy="365760"/>
            </a:xfrm>
            <a:prstGeom prst="rect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A</a:t>
              </a: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9058275" y="6181725"/>
              <a:ext cx="365760" cy="36576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B</a:t>
              </a:r>
            </a:p>
          </p:txBody>
        </p:sp>
        <p:sp>
          <p:nvSpPr>
            <p:cNvPr id="82" name="Rectangle 81"/>
            <p:cNvSpPr/>
            <p:nvPr/>
          </p:nvSpPr>
          <p:spPr>
            <a:xfrm>
              <a:off x="9639300" y="6181725"/>
              <a:ext cx="365760" cy="3657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C</a:t>
              </a:r>
            </a:p>
          </p:txBody>
        </p:sp>
      </p:grpSp>
      <p:sp>
        <p:nvSpPr>
          <p:cNvPr id="84" name="TextBox 83"/>
          <p:cNvSpPr txBox="1"/>
          <p:nvPr/>
        </p:nvSpPr>
        <p:spPr>
          <a:xfrm>
            <a:off x="8771022" y="1504950"/>
            <a:ext cx="535724" cy="4524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3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187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118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62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0640930" y="1504950"/>
            <a:ext cx="535724" cy="4524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0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152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103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46</a:t>
            </a:r>
          </a:p>
        </p:txBody>
      </p:sp>
      <p:grpSp>
        <p:nvGrpSpPr>
          <p:cNvPr id="88" name="Group 87"/>
          <p:cNvGrpSpPr/>
          <p:nvPr/>
        </p:nvGrpSpPr>
        <p:grpSpPr>
          <a:xfrm>
            <a:off x="7709058" y="209550"/>
            <a:ext cx="3235098" cy="5951220"/>
            <a:chOff x="7709058" y="209550"/>
            <a:chExt cx="3235098" cy="595122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/>
            </p:nvPr>
          </p:nvGraphicFramePr>
          <p:xfrm>
            <a:off x="7709058" y="598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/>
            </p:nvPr>
          </p:nvGraphicFramePr>
          <p:xfrm>
            <a:off x="7709058" y="1995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/>
            </p:nvPr>
          </p:nvGraphicFramePr>
          <p:xfrm>
            <a:off x="9572556" y="598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/>
            </p:nvPr>
          </p:nvGraphicFramePr>
          <p:xfrm>
            <a:off x="7709058" y="4789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/>
            </p:nvPr>
          </p:nvGraphicFramePr>
          <p:xfrm>
            <a:off x="9572556" y="1995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0" name="Chart 9"/>
            <p:cNvGraphicFramePr>
              <a:graphicFrameLocks/>
            </p:cNvGraphicFramePr>
            <p:nvPr>
              <p:extLst/>
            </p:nvPr>
          </p:nvGraphicFramePr>
          <p:xfrm>
            <a:off x="9572556" y="4789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74" name="TextBox 75"/>
            <p:cNvSpPr txBox="1"/>
            <p:nvPr/>
          </p:nvSpPr>
          <p:spPr>
            <a:xfrm>
              <a:off x="10033249" y="209550"/>
              <a:ext cx="450215" cy="5003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2800" kern="1200">
                  <a:effectLst/>
                  <a:latin typeface="+mn-ea"/>
                  <a:ea typeface="MS Mincho"/>
                  <a:cs typeface="Times New Roman" panose="02020603050405020304" pitchFamily="18" charset="0"/>
                </a:rPr>
                <a:t>♀</a:t>
              </a:r>
              <a:endParaRPr lang="en-US" sz="1200">
                <a:effectLst/>
                <a:latin typeface="Times New Roman" panose="02020603050405020304" pitchFamily="18" charset="0"/>
                <a:ea typeface="MS Mincho"/>
              </a:endParaRPr>
            </a:p>
          </p:txBody>
        </p:sp>
        <p:sp>
          <p:nvSpPr>
            <p:cNvPr id="75" name="TextBox 78"/>
            <p:cNvSpPr txBox="1"/>
            <p:nvPr/>
          </p:nvSpPr>
          <p:spPr>
            <a:xfrm>
              <a:off x="8169751" y="209550"/>
              <a:ext cx="450215" cy="5003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2800" kern="1200" dirty="0">
                  <a:effectLst/>
                  <a:latin typeface="+mn-ea"/>
                  <a:ea typeface="MS Mincho"/>
                  <a:cs typeface="Times New Roman" panose="02020603050405020304" pitchFamily="18" charset="0"/>
                </a:rPr>
                <a:t>♂</a:t>
              </a:r>
              <a:endParaRPr lang="en-US" sz="1200" dirty="0">
                <a:effectLst/>
                <a:latin typeface="Times New Roman" panose="02020603050405020304" pitchFamily="18" charset="0"/>
                <a:ea typeface="MS Mincho"/>
              </a:endParaRPr>
            </a:p>
          </p:txBody>
        </p:sp>
        <p:graphicFrame>
          <p:nvGraphicFramePr>
            <p:cNvPr id="86" name="Chart 85"/>
            <p:cNvGraphicFramePr>
              <a:graphicFrameLocks/>
            </p:cNvGraphicFramePr>
            <p:nvPr>
              <p:extLst/>
            </p:nvPr>
          </p:nvGraphicFramePr>
          <p:xfrm>
            <a:off x="7709058" y="3392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87" name="Chart 86"/>
            <p:cNvGraphicFramePr>
              <a:graphicFrameLocks/>
            </p:cNvGraphicFramePr>
            <p:nvPr>
              <p:extLst/>
            </p:nvPr>
          </p:nvGraphicFramePr>
          <p:xfrm>
            <a:off x="9572556" y="3392170"/>
            <a:ext cx="1371600" cy="137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034522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8</Words>
  <Application>Microsoft Office PowerPoint</Application>
  <PresentationFormat>Widescreen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yles</dc:creator>
  <cp:lastModifiedBy>mlyles</cp:lastModifiedBy>
  <cp:revision>6</cp:revision>
  <dcterms:created xsi:type="dcterms:W3CDTF">2016-12-27T20:26:56Z</dcterms:created>
  <dcterms:modified xsi:type="dcterms:W3CDTF">2016-12-27T20:29:40Z</dcterms:modified>
</cp:coreProperties>
</file>